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F490B7-C394-4F1D-8752-2D819A07362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353C59-444E-4D31-8D44-7791512858D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8ADC97-DEC4-4C05-8FB7-8ED29A560DB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8C4F4B-A015-4EF5-82D5-554D490BA45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59235A-8C01-4C50-8B95-31C3D1D2E59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21CBC1-8BBB-45D8-8729-57884690F4E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8B45C8-F983-45F3-AD1E-CA3AC93E8B2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E9DAD6-9968-4C9E-A2F0-50659B0374A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535ACA-31F6-404B-87BA-6D057C728C0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EA5DA6-A3DE-4864-85E0-1A3219112D8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652F4D-31E9-42BC-AD7F-28D932E8B2D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CDCA22-8B39-4A1F-9B8F-5227983F608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3FE7B66-0942-4F39-9C03-90C0C64610D1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MADS-box genes involved in orchid morphological evolution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2" name="Content Placeholder 3" descr=""/>
          <p:cNvPicPr/>
          <p:nvPr/>
        </p:nvPicPr>
        <p:blipFill>
          <a:blip r:embed="rId1"/>
          <a:stretch/>
        </p:blipFill>
        <p:spPr>
          <a:xfrm>
            <a:off x="1371600" y="1528920"/>
            <a:ext cx="6400800" cy="3830400"/>
          </a:xfrm>
          <a:prstGeom prst="rect">
            <a:avLst/>
          </a:prstGeom>
          <a:ln w="0">
            <a:noFill/>
          </a:ln>
        </p:spPr>
      </p:pic>
      <p:pic>
        <p:nvPicPr>
          <p:cNvPr id="43" name="Picture 5" descr=""/>
          <p:cNvPicPr/>
          <p:nvPr/>
        </p:nvPicPr>
        <p:blipFill>
          <a:blip r:embed="rId2"/>
          <a:stretch/>
        </p:blipFill>
        <p:spPr>
          <a:xfrm>
            <a:off x="6985080" y="6222960"/>
            <a:ext cx="1333440" cy="279360"/>
          </a:xfrm>
          <a:prstGeom prst="rect">
            <a:avLst/>
          </a:prstGeom>
          <a:ln w="0">
            <a:noFill/>
          </a:ln>
        </p:spPr>
      </p:pic>
      <p:sp>
        <p:nvSpPr>
          <p:cNvPr id="44" name="Title 1"/>
          <p:cNvSpPr/>
          <p:nvPr/>
        </p:nvSpPr>
        <p:spPr>
          <a:xfrm>
            <a:off x="444600" y="5851440"/>
            <a:ext cx="8229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G-Q Zhang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et al. Nature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1–5 (2017) doi:10.1038/nature23897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7-09-11T09:52:47Z</dcterms:created>
  <dc:creator>ravikumar.n</dc:creator>
  <dc:description/>
  <dc:language>en-US</dc:language>
  <cp:lastModifiedBy>ravikumar.n</cp:lastModifiedBy>
  <dcterms:modified xsi:type="dcterms:W3CDTF">2017-09-11T09:52:51Z</dcterms:modified>
  <cp:revision>1</cp:revision>
  <dc:subject/>
  <dc:title>MADS-box genes involved in orchid morphological evolution</dc:title>
</cp:coreProperties>
</file>